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1" r:id="rId3"/>
    <p:sldId id="256" r:id="rId4"/>
    <p:sldId id="257" r:id="rId5"/>
    <p:sldId id="260" r:id="rId6"/>
    <p:sldId id="262" r:id="rId7"/>
    <p:sldId id="263" r:id="rId8"/>
    <p:sldId id="264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66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DBEFC8-86F7-4785-8C80-67B7BCAFD4ED}" type="datetimeFigureOut">
              <a:rPr lang="en-US" smtClean="0"/>
              <a:t>5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3CD07-961C-4308-A1CA-41C0ADC9DB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7601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DBEFC8-86F7-4785-8C80-67B7BCAFD4ED}" type="datetimeFigureOut">
              <a:rPr lang="en-US" smtClean="0"/>
              <a:t>5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3CD07-961C-4308-A1CA-41C0ADC9DB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2930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DBEFC8-86F7-4785-8C80-67B7BCAFD4ED}" type="datetimeFigureOut">
              <a:rPr lang="en-US" smtClean="0"/>
              <a:t>5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3CD07-961C-4308-A1CA-41C0ADC9DB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2262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DBEFC8-86F7-4785-8C80-67B7BCAFD4ED}" type="datetimeFigureOut">
              <a:rPr lang="en-US" smtClean="0"/>
              <a:t>5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3CD07-961C-4308-A1CA-41C0ADC9DB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89711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DBEFC8-86F7-4785-8C80-67B7BCAFD4ED}" type="datetimeFigureOut">
              <a:rPr lang="en-US" smtClean="0"/>
              <a:t>5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3CD07-961C-4308-A1CA-41C0ADC9DB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587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DBEFC8-86F7-4785-8C80-67B7BCAFD4ED}" type="datetimeFigureOut">
              <a:rPr lang="en-US" smtClean="0"/>
              <a:t>5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3CD07-961C-4308-A1CA-41C0ADC9DB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547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DBEFC8-86F7-4785-8C80-67B7BCAFD4ED}" type="datetimeFigureOut">
              <a:rPr lang="en-US" smtClean="0"/>
              <a:t>5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3CD07-961C-4308-A1CA-41C0ADC9DB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0566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DBEFC8-86F7-4785-8C80-67B7BCAFD4ED}" type="datetimeFigureOut">
              <a:rPr lang="en-US" smtClean="0"/>
              <a:t>5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3CD07-961C-4308-A1CA-41C0ADC9DB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50946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DBEFC8-86F7-4785-8C80-67B7BCAFD4ED}" type="datetimeFigureOut">
              <a:rPr lang="en-US" smtClean="0"/>
              <a:t>5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3CD07-961C-4308-A1CA-41C0ADC9DB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34725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DBEFC8-86F7-4785-8C80-67B7BCAFD4ED}" type="datetimeFigureOut">
              <a:rPr lang="en-US" smtClean="0"/>
              <a:t>5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3CD07-961C-4308-A1CA-41C0ADC9DB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21351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DBEFC8-86F7-4785-8C80-67B7BCAFD4ED}" type="datetimeFigureOut">
              <a:rPr lang="en-US" smtClean="0"/>
              <a:t>5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3CD07-961C-4308-A1CA-41C0ADC9DB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808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DBEFC8-86F7-4785-8C80-67B7BCAFD4ED}" type="datetimeFigureOut">
              <a:rPr lang="en-US" smtClean="0"/>
              <a:t>5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3CD07-961C-4308-A1CA-41C0ADC9DB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41433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0073" y="185375"/>
            <a:ext cx="7092833" cy="595088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071533" y="6282267"/>
            <a:ext cx="19944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ice Husk_1-1.mb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792476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10164" y="241068"/>
            <a:ext cx="7075994" cy="593675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071533" y="6282267"/>
            <a:ext cx="19944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ice Husk_1-2.mb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02991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76945" y="325637"/>
            <a:ext cx="7034646" cy="590206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071533" y="6282267"/>
            <a:ext cx="19944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ice Husk_1-3.mb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023515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35381" y="414043"/>
            <a:ext cx="6733310" cy="564924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071533" y="6282267"/>
            <a:ext cx="19944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ice Husk_1-4.mb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978717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01871" y="250921"/>
            <a:ext cx="6951778" cy="583254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071533" y="6282267"/>
            <a:ext cx="19944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ice Husk_1-5.mb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241676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82332" y="213163"/>
            <a:ext cx="7047421" cy="591278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071533" y="6282267"/>
            <a:ext cx="26068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ice Husk_Inner_3-1.mb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6839300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7310" y="406401"/>
            <a:ext cx="9869182" cy="480642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071533" y="6282267"/>
            <a:ext cx="3904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ice Husk EDX Outer Spectra-Raw File-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0281986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8267" y="474848"/>
            <a:ext cx="10893424" cy="530523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071533" y="6282267"/>
            <a:ext cx="38569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ice Husk EDX Inner Spectra-Raw File-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815547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24</Words>
  <Application>Microsoft Office PowerPoint</Application>
  <PresentationFormat>Widescreen</PresentationFormat>
  <Paragraphs>8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North Carolina Stat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aveen Kolar</dc:creator>
  <cp:lastModifiedBy>Praveen Kolar</cp:lastModifiedBy>
  <cp:revision>2</cp:revision>
  <dcterms:created xsi:type="dcterms:W3CDTF">2019-05-10T20:27:03Z</dcterms:created>
  <dcterms:modified xsi:type="dcterms:W3CDTF">2019-05-10T20:34:05Z</dcterms:modified>
</cp:coreProperties>
</file>